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6" r:id="rId2"/>
    <p:sldId id="257" r:id="rId3"/>
    <p:sldId id="261" r:id="rId4"/>
    <p:sldId id="262" r:id="rId5"/>
    <p:sldId id="258" r:id="rId6"/>
    <p:sldId id="259" r:id="rId7"/>
    <p:sldId id="260" r:id="rId8"/>
    <p:sldId id="267" r:id="rId9"/>
    <p:sldId id="271" r:id="rId10"/>
    <p:sldId id="269" r:id="rId11"/>
    <p:sldId id="270" r:id="rId12"/>
    <p:sldId id="272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2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D85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272" autoAdjust="0"/>
    <p:restoredTop sz="94660"/>
  </p:normalViewPr>
  <p:slideViewPr>
    <p:cSldViewPr snapToGrid="0" showGuides="1">
      <p:cViewPr varScale="1">
        <p:scale>
          <a:sx n="91" d="100"/>
          <a:sy n="91" d="100"/>
        </p:scale>
        <p:origin x="84" y="606"/>
      </p:cViewPr>
      <p:guideLst>
        <p:guide orient="horz" pos="482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410B8B-0BCA-453D-9046-A0E343643308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BBC9DD-38CD-43B2-8534-81DC1EA6F1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06625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FBBC9DD-38CD-43B2-8534-81DC1EA6F1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42902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https://bioinformatics.psb.ugent.be/webtools/Venn/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CEB7EC-B580-49A9-B06F-C622F8D65811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41091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0B695-1F8B-4EB9-83BA-57C28B7DBF90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1F31-8852-4490-9B5A-3AA1E8089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0739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0B695-1F8B-4EB9-83BA-57C28B7DBF90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1F31-8852-4490-9B5A-3AA1E8089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86651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0B695-1F8B-4EB9-83BA-57C28B7DBF90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1F31-8852-4490-9B5A-3AA1E8089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170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0B695-1F8B-4EB9-83BA-57C28B7DBF90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1F31-8852-4490-9B5A-3AA1E8089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7353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0B695-1F8B-4EB9-83BA-57C28B7DBF90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1F31-8852-4490-9B5A-3AA1E8089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38537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0B695-1F8B-4EB9-83BA-57C28B7DBF90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1F31-8852-4490-9B5A-3AA1E8089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59128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0B695-1F8B-4EB9-83BA-57C28B7DBF90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1F31-8852-4490-9B5A-3AA1E8089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81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0B695-1F8B-4EB9-83BA-57C28B7DBF90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1F31-8852-4490-9B5A-3AA1E8089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4148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0B695-1F8B-4EB9-83BA-57C28B7DBF90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1F31-8852-4490-9B5A-3AA1E8089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1191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0B695-1F8B-4EB9-83BA-57C28B7DBF90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1F31-8852-4490-9B5A-3AA1E8089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206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0B695-1F8B-4EB9-83BA-57C28B7DBF90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1F31-8852-4490-9B5A-3AA1E8089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4195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60B695-1F8B-4EB9-83BA-57C28B7DBF90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311F31-8852-4490-9B5A-3AA1E8089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6843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50932" y="508157"/>
            <a:ext cx="11290137" cy="5841687"/>
            <a:chOff x="450932" y="508157"/>
            <a:chExt cx="11290137" cy="5841687"/>
          </a:xfrm>
        </p:grpSpPr>
        <p:grpSp>
          <p:nvGrpSpPr>
            <p:cNvPr id="10" name="Group 9"/>
            <p:cNvGrpSpPr/>
            <p:nvPr/>
          </p:nvGrpSpPr>
          <p:grpSpPr>
            <a:xfrm>
              <a:off x="450932" y="508157"/>
              <a:ext cx="11290137" cy="5841687"/>
              <a:chOff x="223684" y="808038"/>
              <a:chExt cx="9817510" cy="5079728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64394" y="4058966"/>
                <a:ext cx="4876800" cy="1828800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3684" y="808038"/>
                <a:ext cx="4876800" cy="1828800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64394" y="2433504"/>
                <a:ext cx="4876800" cy="182880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64394" y="808038"/>
                <a:ext cx="4876800" cy="1828800"/>
              </a:xfrm>
              <a:prstGeom prst="rect">
                <a:avLst/>
              </a:prstGeom>
            </p:spPr>
          </p:pic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3684" y="2433504"/>
                <a:ext cx="4876800" cy="1828800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3684" y="4058966"/>
                <a:ext cx="4876800" cy="1828800"/>
              </a:xfrm>
              <a:prstGeom prst="rect">
                <a:avLst/>
              </a:prstGeom>
            </p:spPr>
          </p:pic>
        </p:grpSp>
        <p:sp>
          <p:nvSpPr>
            <p:cNvPr id="2" name="TextBox 1"/>
            <p:cNvSpPr txBox="1"/>
            <p:nvPr/>
          </p:nvSpPr>
          <p:spPr>
            <a:xfrm>
              <a:off x="2486706" y="588860"/>
              <a:ext cx="162172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/>
                <a:t>MWAS Control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622160" y="2397888"/>
              <a:ext cx="1350819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/>
                <a:t>MWAS MDD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582084" y="4275073"/>
              <a:ext cx="1430969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/>
                <a:t>MWAS </a:t>
              </a:r>
              <a:r>
                <a:rPr lang="en-GB" dirty="0" err="1"/>
                <a:t>rMDD</a:t>
              </a:r>
              <a:endParaRPr lang="en-GB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222672" y="588860"/>
              <a:ext cx="149752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/>
                <a:t>MWEIS </a:t>
              </a:r>
              <a:r>
                <a:rPr lang="en-GB" dirty="0" err="1"/>
                <a:t>xMDD</a:t>
              </a:r>
              <a:endParaRPr lang="en-GB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8182597" y="2397888"/>
              <a:ext cx="157767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/>
                <a:t>MWEIS </a:t>
              </a:r>
              <a:r>
                <a:rPr lang="en-GB" dirty="0" err="1"/>
                <a:t>xrMDD</a:t>
              </a:r>
              <a:endParaRPr lang="en-GB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8289229" y="4275073"/>
              <a:ext cx="136441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/>
                <a:t>MWAS Meta</a:t>
              </a: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350988" y="108047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Supplementary Figure 1</a:t>
            </a:r>
          </a:p>
        </p:txBody>
      </p:sp>
      <p:sp>
        <p:nvSpPr>
          <p:cNvPr id="17" name="Rectangle 16"/>
          <p:cNvSpPr/>
          <p:nvPr/>
        </p:nvSpPr>
        <p:spPr>
          <a:xfrm>
            <a:off x="4423202" y="697189"/>
            <a:ext cx="107593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dirty="0"/>
              <a:t>cg14764459</a:t>
            </a:r>
            <a:endParaRPr lang="en-GB" dirty="0"/>
          </a:p>
        </p:txBody>
      </p:sp>
      <p:sp>
        <p:nvSpPr>
          <p:cNvPr id="18" name="Rectangle 17"/>
          <p:cNvSpPr/>
          <p:nvPr/>
        </p:nvSpPr>
        <p:spPr>
          <a:xfrm>
            <a:off x="10085377" y="4440126"/>
            <a:ext cx="107593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dirty="0"/>
              <a:t>cg14764459</a:t>
            </a:r>
            <a:endParaRPr lang="en-GB" dirty="0"/>
          </a:p>
        </p:txBody>
      </p:sp>
      <p:sp>
        <p:nvSpPr>
          <p:cNvPr id="19" name="Rectangle 18"/>
          <p:cNvSpPr/>
          <p:nvPr/>
        </p:nvSpPr>
        <p:spPr>
          <a:xfrm>
            <a:off x="10377711" y="2459443"/>
            <a:ext cx="107593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dirty="0"/>
              <a:t>cg02101279</a:t>
            </a:r>
            <a:endParaRPr lang="en-GB" dirty="0"/>
          </a:p>
        </p:txBody>
      </p:sp>
      <p:sp>
        <p:nvSpPr>
          <p:cNvPr id="20" name="Oval 19"/>
          <p:cNvSpPr>
            <a:spLocks noChangeAspect="1"/>
          </p:cNvSpPr>
          <p:nvPr/>
        </p:nvSpPr>
        <p:spPr>
          <a:xfrm>
            <a:off x="11412000" y="2687928"/>
            <a:ext cx="14400" cy="14400"/>
          </a:xfrm>
          <a:prstGeom prst="ellipse">
            <a:avLst/>
          </a:prstGeom>
          <a:solidFill>
            <a:srgbClr val="CD8500"/>
          </a:solidFill>
          <a:ln>
            <a:solidFill>
              <a:srgbClr val="CD85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12254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294337" y="532707"/>
            <a:ext cx="9603326" cy="6160437"/>
            <a:chOff x="491446" y="785803"/>
            <a:chExt cx="9603326" cy="6160437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98478" y="4049946"/>
              <a:ext cx="2896294" cy="2896294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98478" y="785803"/>
              <a:ext cx="2896294" cy="2896294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1446" y="4049946"/>
              <a:ext cx="6707032" cy="2896294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1446" y="785803"/>
              <a:ext cx="6707032" cy="2896294"/>
            </a:xfrm>
            <a:prstGeom prst="rect">
              <a:avLst/>
            </a:prstGeom>
          </p:spPr>
        </p:pic>
      </p:grpSp>
      <p:sp>
        <p:nvSpPr>
          <p:cNvPr id="9" name="TextBox 8"/>
          <p:cNvSpPr txBox="1"/>
          <p:nvPr/>
        </p:nvSpPr>
        <p:spPr>
          <a:xfrm>
            <a:off x="350988" y="108047"/>
            <a:ext cx="110897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Supplementary Figure 10: SNP and gene-based Manhattan plots of the adult trauma GWAS in UK Biobank</a:t>
            </a:r>
          </a:p>
        </p:txBody>
      </p:sp>
    </p:spTree>
    <p:extLst>
      <p:ext uri="{BB962C8B-B14F-4D97-AF65-F5344CB8AC3E}">
        <p14:creationId xmlns:p14="http://schemas.microsoft.com/office/powerpoint/2010/main" val="81595642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7763" y="652315"/>
            <a:ext cx="4764034" cy="238049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50988" y="108047"/>
            <a:ext cx="85528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Supplementary Figure 11: MAGMA results for adult trauma GWAS in UK Biobank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4CF4CBD-7186-43B0-AAA2-74354F3A82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107" y="3176966"/>
            <a:ext cx="8972615" cy="34220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656739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1296" y="567556"/>
            <a:ext cx="5105092" cy="411001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50988" y="108047"/>
            <a:ext cx="94423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Supplementary Figure 12: </a:t>
            </a:r>
            <a:r>
              <a:rPr lang="en-GB" sz="2000" dirty="0" err="1"/>
              <a:t>GTEx</a:t>
            </a:r>
            <a:r>
              <a:rPr lang="en-GB" sz="2000" dirty="0"/>
              <a:t> enrichment results for adult trauma GWAS in UK Biobank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9A95624-189E-4132-A4F9-401BBC758E2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824" y="2144416"/>
            <a:ext cx="8763018" cy="46055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11268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13102" y="1302367"/>
            <a:ext cx="5006338" cy="3995305"/>
            <a:chOff x="613102" y="1302367"/>
            <a:chExt cx="5006338" cy="3995305"/>
          </a:xfrm>
        </p:grpSpPr>
        <p:sp>
          <p:nvSpPr>
            <p:cNvPr id="18" name="Oval 17"/>
            <p:cNvSpPr/>
            <p:nvPr/>
          </p:nvSpPr>
          <p:spPr>
            <a:xfrm>
              <a:off x="1610114" y="1497542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9" name="Oval 18"/>
            <p:cNvSpPr/>
            <p:nvPr/>
          </p:nvSpPr>
          <p:spPr>
            <a:xfrm>
              <a:off x="2150114" y="2577542"/>
              <a:ext cx="2160000" cy="2160000"/>
            </a:xfrm>
            <a:prstGeom prst="ellipse">
              <a:avLst/>
            </a:prstGeom>
            <a:solidFill>
              <a:srgbClr val="92D05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20" name="Oval 19"/>
            <p:cNvSpPr/>
            <p:nvPr/>
          </p:nvSpPr>
          <p:spPr>
            <a:xfrm>
              <a:off x="2690114" y="1497542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21" name="TextBox 6"/>
            <p:cNvSpPr txBox="1"/>
            <p:nvPr/>
          </p:nvSpPr>
          <p:spPr>
            <a:xfrm>
              <a:off x="1875039" y="2037542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/>
                <a:t>7</a:t>
              </a:r>
            </a:p>
          </p:txBody>
        </p:sp>
        <p:sp>
          <p:nvSpPr>
            <p:cNvPr id="22" name="TextBox 7"/>
            <p:cNvSpPr txBox="1"/>
            <p:nvPr/>
          </p:nvSpPr>
          <p:spPr>
            <a:xfrm>
              <a:off x="3050919" y="1857542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/>
                <a:t>0</a:t>
              </a:r>
            </a:p>
          </p:txBody>
        </p:sp>
        <p:sp>
          <p:nvSpPr>
            <p:cNvPr id="23" name="TextBox 8"/>
            <p:cNvSpPr txBox="1"/>
            <p:nvPr/>
          </p:nvSpPr>
          <p:spPr>
            <a:xfrm>
              <a:off x="4035038" y="2037542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/>
                <a:t>9</a:t>
              </a:r>
            </a:p>
          </p:txBody>
        </p:sp>
        <p:sp>
          <p:nvSpPr>
            <p:cNvPr id="24" name="TextBox 9"/>
            <p:cNvSpPr txBox="1"/>
            <p:nvPr/>
          </p:nvSpPr>
          <p:spPr>
            <a:xfrm>
              <a:off x="2426022" y="3081542"/>
              <a:ext cx="6228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/>
                <a:t>0</a:t>
              </a:r>
            </a:p>
          </p:txBody>
        </p:sp>
        <p:sp>
          <p:nvSpPr>
            <p:cNvPr id="25" name="TextBox 10"/>
            <p:cNvSpPr txBox="1"/>
            <p:nvPr/>
          </p:nvSpPr>
          <p:spPr>
            <a:xfrm>
              <a:off x="3076778" y="2705811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/>
                <a:t>0</a:t>
              </a:r>
            </a:p>
          </p:txBody>
        </p:sp>
        <p:sp>
          <p:nvSpPr>
            <p:cNvPr id="26" name="TextBox 11"/>
            <p:cNvSpPr txBox="1"/>
            <p:nvPr/>
          </p:nvSpPr>
          <p:spPr>
            <a:xfrm>
              <a:off x="3622103" y="3081542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/>
                <a:t>10</a:t>
              </a:r>
            </a:p>
          </p:txBody>
        </p:sp>
        <p:sp>
          <p:nvSpPr>
            <p:cNvPr id="27" name="TextBox 12"/>
            <p:cNvSpPr txBox="1"/>
            <p:nvPr/>
          </p:nvSpPr>
          <p:spPr>
            <a:xfrm>
              <a:off x="2992304" y="3933248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/>
                <a:t>14</a:t>
              </a:r>
            </a:p>
          </p:txBody>
        </p:sp>
        <p:sp>
          <p:nvSpPr>
            <p:cNvPr id="28" name="TextBox 13"/>
            <p:cNvSpPr txBox="1"/>
            <p:nvPr/>
          </p:nvSpPr>
          <p:spPr>
            <a:xfrm>
              <a:off x="613102" y="1302367"/>
              <a:ext cx="12607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/>
                <a:t>Control</a:t>
              </a:r>
            </a:p>
          </p:txBody>
        </p:sp>
        <p:sp>
          <p:nvSpPr>
            <p:cNvPr id="29" name="TextBox 14"/>
            <p:cNvSpPr txBox="1"/>
            <p:nvPr/>
          </p:nvSpPr>
          <p:spPr>
            <a:xfrm>
              <a:off x="4559534" y="1302367"/>
              <a:ext cx="105990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 err="1"/>
                <a:t>rMDD</a:t>
              </a:r>
              <a:endParaRPr lang="en-GB" sz="2800" dirty="0"/>
            </a:p>
          </p:txBody>
        </p:sp>
        <p:sp>
          <p:nvSpPr>
            <p:cNvPr id="30" name="TextBox 15"/>
            <p:cNvSpPr txBox="1"/>
            <p:nvPr/>
          </p:nvSpPr>
          <p:spPr>
            <a:xfrm>
              <a:off x="2715556" y="4774452"/>
              <a:ext cx="121539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 err="1"/>
                <a:t>xrMDD</a:t>
              </a:r>
              <a:endParaRPr lang="en-GB" sz="2800" dirty="0"/>
            </a:p>
          </p:txBody>
        </p:sp>
      </p:grpSp>
      <p:sp>
        <p:nvSpPr>
          <p:cNvPr id="31" name="TextBox 16"/>
          <p:cNvSpPr txBox="1"/>
          <p:nvPr/>
        </p:nvSpPr>
        <p:spPr>
          <a:xfrm>
            <a:off x="4874351" y="1571"/>
            <a:ext cx="24432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2800" dirty="0"/>
              <a:t>Genes P&lt;1x10</a:t>
            </a:r>
            <a:r>
              <a:rPr lang="en-GB" sz="2800" baseline="30000" dirty="0"/>
              <a:t>-5</a:t>
            </a:r>
          </a:p>
        </p:txBody>
      </p:sp>
      <p:sp>
        <p:nvSpPr>
          <p:cNvPr id="5" name="TextBox 18"/>
          <p:cNvSpPr txBox="1"/>
          <p:nvPr/>
        </p:nvSpPr>
        <p:spPr>
          <a:xfrm>
            <a:off x="163913" y="6295662"/>
            <a:ext cx="1284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P &lt; 0.00001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6586946" y="1457680"/>
            <a:ext cx="5006338" cy="2355175"/>
            <a:chOff x="2330845" y="1300796"/>
            <a:chExt cx="5006338" cy="2355175"/>
          </a:xfrm>
        </p:grpSpPr>
        <p:sp>
          <p:nvSpPr>
            <p:cNvPr id="11" name="Oval 10"/>
            <p:cNvSpPr/>
            <p:nvPr/>
          </p:nvSpPr>
          <p:spPr>
            <a:xfrm>
              <a:off x="3327857" y="1495971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2" name="Oval 11"/>
            <p:cNvSpPr/>
            <p:nvPr/>
          </p:nvSpPr>
          <p:spPr>
            <a:xfrm>
              <a:off x="4407857" y="1495971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3" name="TextBox 22"/>
            <p:cNvSpPr txBox="1"/>
            <p:nvPr/>
          </p:nvSpPr>
          <p:spPr>
            <a:xfrm>
              <a:off x="3581896" y="2314361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/>
                <a:t>7</a:t>
              </a:r>
            </a:p>
          </p:txBody>
        </p:sp>
        <p:sp>
          <p:nvSpPr>
            <p:cNvPr id="14" name="TextBox 23"/>
            <p:cNvSpPr txBox="1"/>
            <p:nvPr/>
          </p:nvSpPr>
          <p:spPr>
            <a:xfrm>
              <a:off x="4776195" y="2314361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/>
                <a:t>0</a:t>
              </a:r>
            </a:p>
          </p:txBody>
        </p:sp>
        <p:sp>
          <p:nvSpPr>
            <p:cNvPr id="15" name="TextBox 24"/>
            <p:cNvSpPr txBox="1"/>
            <p:nvPr/>
          </p:nvSpPr>
          <p:spPr>
            <a:xfrm>
              <a:off x="5665693" y="2314361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/>
                <a:t>19</a:t>
              </a:r>
            </a:p>
          </p:txBody>
        </p:sp>
        <p:sp>
          <p:nvSpPr>
            <p:cNvPr id="16" name="TextBox 25"/>
            <p:cNvSpPr txBox="1"/>
            <p:nvPr/>
          </p:nvSpPr>
          <p:spPr>
            <a:xfrm>
              <a:off x="2330845" y="1300796"/>
              <a:ext cx="12607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/>
                <a:t>Control</a:t>
              </a:r>
            </a:p>
          </p:txBody>
        </p:sp>
        <p:sp>
          <p:nvSpPr>
            <p:cNvPr id="17" name="TextBox 26"/>
            <p:cNvSpPr txBox="1"/>
            <p:nvPr/>
          </p:nvSpPr>
          <p:spPr>
            <a:xfrm>
              <a:off x="6277277" y="1300796"/>
              <a:ext cx="105990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2800" dirty="0" err="1"/>
                <a:t>rMDD</a:t>
              </a:r>
              <a:endParaRPr lang="en-GB" sz="2800" dirty="0"/>
            </a:p>
          </p:txBody>
        </p:sp>
      </p:grpSp>
      <p:pic>
        <p:nvPicPr>
          <p:cNvPr id="7" name="table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6650" y="4646630"/>
            <a:ext cx="7948246" cy="2209800"/>
          </a:xfrm>
          <a:prstGeom prst="rect">
            <a:avLst/>
          </a:prstGeom>
        </p:spPr>
      </p:pic>
      <p:sp>
        <p:nvSpPr>
          <p:cNvPr id="8" name="Oval 7"/>
          <p:cNvSpPr/>
          <p:nvPr/>
        </p:nvSpPr>
        <p:spPr>
          <a:xfrm>
            <a:off x="57104" y="4117427"/>
            <a:ext cx="2160000" cy="2160000"/>
          </a:xfrm>
          <a:prstGeom prst="ellipse">
            <a:avLst/>
          </a:prstGeom>
          <a:solidFill>
            <a:srgbClr val="CC99FF">
              <a:alpha val="49804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GB"/>
          </a:p>
        </p:txBody>
      </p:sp>
      <p:sp>
        <p:nvSpPr>
          <p:cNvPr id="9" name="TextBox 28"/>
          <p:cNvSpPr txBox="1"/>
          <p:nvPr/>
        </p:nvSpPr>
        <p:spPr>
          <a:xfrm>
            <a:off x="695498" y="4149140"/>
            <a:ext cx="97699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2800" b="1" dirty="0"/>
              <a:t>Meta</a:t>
            </a:r>
          </a:p>
        </p:txBody>
      </p:sp>
      <p:pic>
        <p:nvPicPr>
          <p:cNvPr id="10" name="table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5931" y="4620756"/>
            <a:ext cx="1760903" cy="1318260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350988" y="108047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12114140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37618" y="1226506"/>
            <a:ext cx="4881303" cy="3995305"/>
            <a:chOff x="537618" y="1226506"/>
            <a:chExt cx="4881303" cy="3995305"/>
          </a:xfrm>
        </p:grpSpPr>
        <p:sp>
          <p:nvSpPr>
            <p:cNvPr id="5" name="Oval 4"/>
            <p:cNvSpPr/>
            <p:nvPr/>
          </p:nvSpPr>
          <p:spPr>
            <a:xfrm>
              <a:off x="1534630" y="1421681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" name="Oval 5"/>
            <p:cNvSpPr/>
            <p:nvPr/>
          </p:nvSpPr>
          <p:spPr>
            <a:xfrm>
              <a:off x="2074630" y="2501681"/>
              <a:ext cx="2160000" cy="2160000"/>
            </a:xfrm>
            <a:prstGeom prst="ellipse">
              <a:avLst/>
            </a:prstGeom>
            <a:solidFill>
              <a:srgbClr val="92D05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Oval 6"/>
            <p:cNvSpPr/>
            <p:nvPr/>
          </p:nvSpPr>
          <p:spPr>
            <a:xfrm>
              <a:off x="2614630" y="1421681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86643" y="1961681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80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887879" y="1781681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52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911224" y="1961681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121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270690" y="3005681"/>
              <a:ext cx="6228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21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802726" y="2629950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59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466819" y="3005681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91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872691" y="3857387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36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37618" y="1226506"/>
              <a:ext cx="12607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Control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484050" y="1226506"/>
              <a:ext cx="93487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MDD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640072" y="4698591"/>
              <a:ext cx="109036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xMDD</a:t>
              </a:r>
              <a:endParaRPr lang="en-GB" sz="2800" dirty="0"/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5859859" y="6257557"/>
            <a:ext cx="15263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DR Sig &lt; 0.05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436058" y="461441"/>
            <a:ext cx="142341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Same effect in MDD &amp; Control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881111" y="2659798"/>
            <a:ext cx="142341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Effects differ in MDD &amp; Control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436443" y="3680476"/>
            <a:ext cx="14234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Effects only in MDD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37618" y="3680475"/>
            <a:ext cx="14234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Effects only in Control</a:t>
            </a:r>
          </a:p>
        </p:txBody>
      </p:sp>
      <p:grpSp>
        <p:nvGrpSpPr>
          <p:cNvPr id="24" name="Group 23"/>
          <p:cNvGrpSpPr/>
          <p:nvPr/>
        </p:nvGrpSpPr>
        <p:grpSpPr>
          <a:xfrm>
            <a:off x="6644050" y="1459250"/>
            <a:ext cx="4881303" cy="2355175"/>
            <a:chOff x="2330845" y="1300796"/>
            <a:chExt cx="4881303" cy="2355175"/>
          </a:xfrm>
        </p:grpSpPr>
        <p:sp>
          <p:nvSpPr>
            <p:cNvPr id="25" name="Oval 24"/>
            <p:cNvSpPr/>
            <p:nvPr/>
          </p:nvSpPr>
          <p:spPr>
            <a:xfrm>
              <a:off x="3327857" y="1495971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" name="Oval 25"/>
            <p:cNvSpPr/>
            <p:nvPr/>
          </p:nvSpPr>
          <p:spPr>
            <a:xfrm>
              <a:off x="4407857" y="1495971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592782" y="2314361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101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600350" y="2314361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311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665693" y="2314361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12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330845" y="1300796"/>
              <a:ext cx="12607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Control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277277" y="1300796"/>
              <a:ext cx="93487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MDD</a:t>
              </a: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8109857" y="4698591"/>
            <a:ext cx="2057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O gene sets 10532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50988" y="108047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37863651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537618" y="1226506"/>
            <a:ext cx="5006338" cy="3995305"/>
            <a:chOff x="2602988" y="1964825"/>
            <a:chExt cx="5006338" cy="3995305"/>
          </a:xfrm>
        </p:grpSpPr>
        <p:sp>
          <p:nvSpPr>
            <p:cNvPr id="4" name="Oval 3"/>
            <p:cNvSpPr/>
            <p:nvPr/>
          </p:nvSpPr>
          <p:spPr>
            <a:xfrm>
              <a:off x="3600000" y="2160000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Oval 4"/>
            <p:cNvSpPr/>
            <p:nvPr/>
          </p:nvSpPr>
          <p:spPr>
            <a:xfrm>
              <a:off x="4140000" y="3240000"/>
              <a:ext cx="2160000" cy="2160000"/>
            </a:xfrm>
            <a:prstGeom prst="ellipse">
              <a:avLst/>
            </a:prstGeom>
            <a:solidFill>
              <a:srgbClr val="92D05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" name="Oval 5"/>
            <p:cNvSpPr/>
            <p:nvPr/>
          </p:nvSpPr>
          <p:spPr>
            <a:xfrm>
              <a:off x="4680000" y="2160000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952013" y="2700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72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995289" y="2520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65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976594" y="2700000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127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336060" y="3744000"/>
              <a:ext cx="6228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15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868096" y="3368269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60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532189" y="3744000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111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963819" y="4595706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3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602988" y="1964825"/>
              <a:ext cx="12607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Control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549420" y="1964825"/>
              <a:ext cx="105990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rMDD</a:t>
              </a:r>
              <a:endParaRPr lang="en-GB" sz="28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705442" y="5436910"/>
              <a:ext cx="121539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xrMDD</a:t>
              </a:r>
              <a:endParaRPr lang="en-GB" sz="2800" dirty="0"/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5859859" y="6257557"/>
            <a:ext cx="15263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DR Sig &lt; 0.05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487808" y="481450"/>
            <a:ext cx="142341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Same effect in MDD &amp; Control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881111" y="2659798"/>
            <a:ext cx="142341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Effects differ in MDD &amp; Control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436443" y="3680476"/>
            <a:ext cx="14234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Effects only in MDD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239305" y="3617669"/>
            <a:ext cx="14234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Effects only in Control</a:t>
            </a:r>
          </a:p>
        </p:txBody>
      </p:sp>
      <p:grpSp>
        <p:nvGrpSpPr>
          <p:cNvPr id="23" name="Group 22"/>
          <p:cNvGrpSpPr/>
          <p:nvPr/>
        </p:nvGrpSpPr>
        <p:grpSpPr>
          <a:xfrm>
            <a:off x="6644050" y="1459250"/>
            <a:ext cx="5006338" cy="2355175"/>
            <a:chOff x="2330845" y="1300796"/>
            <a:chExt cx="5006338" cy="2355175"/>
          </a:xfrm>
        </p:grpSpPr>
        <p:sp>
          <p:nvSpPr>
            <p:cNvPr id="24" name="Oval 23"/>
            <p:cNvSpPr/>
            <p:nvPr/>
          </p:nvSpPr>
          <p:spPr>
            <a:xfrm>
              <a:off x="3327857" y="1495971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" name="Oval 24"/>
            <p:cNvSpPr/>
            <p:nvPr/>
          </p:nvSpPr>
          <p:spPr>
            <a:xfrm>
              <a:off x="4407857" y="1495971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592782" y="2314361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87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600350" y="2314361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325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665693" y="2314361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38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330845" y="1300796"/>
              <a:ext cx="12607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Control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277277" y="1300796"/>
              <a:ext cx="105990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rMDD</a:t>
              </a:r>
              <a:endParaRPr lang="en-GB" sz="2800" dirty="0"/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8109857" y="4698591"/>
            <a:ext cx="2057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O gene sets 10532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350988" y="108047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23514381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670206" y="3141"/>
            <a:ext cx="6807390" cy="5296101"/>
            <a:chOff x="2602988" y="664029"/>
            <a:chExt cx="6807390" cy="5296101"/>
          </a:xfrm>
        </p:grpSpPr>
        <p:sp>
          <p:nvSpPr>
            <p:cNvPr id="4" name="Oval 3"/>
            <p:cNvSpPr/>
            <p:nvPr/>
          </p:nvSpPr>
          <p:spPr>
            <a:xfrm>
              <a:off x="3600000" y="2160000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Oval 4"/>
            <p:cNvSpPr/>
            <p:nvPr/>
          </p:nvSpPr>
          <p:spPr>
            <a:xfrm>
              <a:off x="4140000" y="3240000"/>
              <a:ext cx="2160000" cy="2160000"/>
            </a:xfrm>
            <a:prstGeom prst="ellipse">
              <a:avLst/>
            </a:prstGeom>
            <a:solidFill>
              <a:srgbClr val="92D05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" name="Oval 5"/>
            <p:cNvSpPr/>
            <p:nvPr/>
          </p:nvSpPr>
          <p:spPr>
            <a:xfrm>
              <a:off x="4680000" y="2160000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864925" y="2700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49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970467" y="2520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44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024924" y="2700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78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322124" y="3744000"/>
              <a:ext cx="6228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12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879096" y="3368269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190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611989" y="3744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75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970467" y="4595706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15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602988" y="1964825"/>
              <a:ext cx="12607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Control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549420" y="1964825"/>
              <a:ext cx="105990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rMDD</a:t>
              </a:r>
              <a:endParaRPr lang="en-GB" sz="28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705442" y="5436910"/>
              <a:ext cx="121539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xrMDD</a:t>
              </a:r>
              <a:endParaRPr lang="en-GB" sz="28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647186" y="664029"/>
              <a:ext cx="276319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Biological Process</a:t>
              </a: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221017" y="6297232"/>
            <a:ext cx="1508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DR Sig &lt; 0.05</a:t>
            </a:r>
          </a:p>
        </p:txBody>
      </p:sp>
      <p:grpSp>
        <p:nvGrpSpPr>
          <p:cNvPr id="20" name="Group 19"/>
          <p:cNvGrpSpPr/>
          <p:nvPr/>
        </p:nvGrpSpPr>
        <p:grpSpPr>
          <a:xfrm>
            <a:off x="6644050" y="1459250"/>
            <a:ext cx="5006338" cy="2355175"/>
            <a:chOff x="2330845" y="1300796"/>
            <a:chExt cx="5006338" cy="2355175"/>
          </a:xfrm>
        </p:grpSpPr>
        <p:sp>
          <p:nvSpPr>
            <p:cNvPr id="21" name="Oval 20"/>
            <p:cNvSpPr/>
            <p:nvPr/>
          </p:nvSpPr>
          <p:spPr>
            <a:xfrm>
              <a:off x="3327857" y="1495971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Oval 21"/>
            <p:cNvSpPr/>
            <p:nvPr/>
          </p:nvSpPr>
          <p:spPr>
            <a:xfrm>
              <a:off x="4407857" y="1495971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581896" y="2314361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61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600350" y="2314361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34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665693" y="2314361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153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330845" y="1300796"/>
              <a:ext cx="12607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Control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277277" y="1300796"/>
              <a:ext cx="105990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rMDD</a:t>
              </a:r>
              <a:endParaRPr lang="en-GB" sz="2800" dirty="0"/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350988" y="108047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20756709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537618" y="63291"/>
            <a:ext cx="7079857" cy="5158520"/>
            <a:chOff x="2602988" y="801610"/>
            <a:chExt cx="7079857" cy="5158520"/>
          </a:xfrm>
        </p:grpSpPr>
        <p:sp>
          <p:nvSpPr>
            <p:cNvPr id="4" name="Oval 3"/>
            <p:cNvSpPr/>
            <p:nvPr/>
          </p:nvSpPr>
          <p:spPr>
            <a:xfrm>
              <a:off x="3600000" y="2160000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Oval 4"/>
            <p:cNvSpPr/>
            <p:nvPr/>
          </p:nvSpPr>
          <p:spPr>
            <a:xfrm>
              <a:off x="4140000" y="3240000"/>
              <a:ext cx="2160000" cy="2160000"/>
            </a:xfrm>
            <a:prstGeom prst="ellipse">
              <a:avLst/>
            </a:prstGeom>
            <a:solidFill>
              <a:srgbClr val="92D05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" name="Oval 5"/>
            <p:cNvSpPr/>
            <p:nvPr/>
          </p:nvSpPr>
          <p:spPr>
            <a:xfrm>
              <a:off x="4680000" y="2160000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952013" y="2700000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7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068441" y="2520000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8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987434" y="2700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15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409212" y="3744000"/>
              <a:ext cx="6228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2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966184" y="3368269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42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611989" y="3744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17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105931" y="4595706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6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602988" y="1964825"/>
              <a:ext cx="12607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Control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549420" y="1964825"/>
              <a:ext cx="105990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rMDD</a:t>
              </a:r>
              <a:endParaRPr lang="en-GB" sz="28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705442" y="5436910"/>
              <a:ext cx="121539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xrMDD</a:t>
              </a:r>
              <a:endParaRPr lang="en-GB" sz="28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639896" y="801610"/>
              <a:ext cx="304294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Cellular component</a:t>
              </a: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5501510" y="6301811"/>
            <a:ext cx="1508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DR Sig &lt; 0.05</a:t>
            </a:r>
          </a:p>
        </p:txBody>
      </p:sp>
      <p:grpSp>
        <p:nvGrpSpPr>
          <p:cNvPr id="20" name="Group 19"/>
          <p:cNvGrpSpPr/>
          <p:nvPr/>
        </p:nvGrpSpPr>
        <p:grpSpPr>
          <a:xfrm>
            <a:off x="6644050" y="1459250"/>
            <a:ext cx="5006338" cy="2355175"/>
            <a:chOff x="2330845" y="1300796"/>
            <a:chExt cx="5006338" cy="2355175"/>
          </a:xfrm>
        </p:grpSpPr>
        <p:sp>
          <p:nvSpPr>
            <p:cNvPr id="21" name="Oval 20"/>
            <p:cNvSpPr/>
            <p:nvPr/>
          </p:nvSpPr>
          <p:spPr>
            <a:xfrm>
              <a:off x="3327857" y="1495971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Oval 21"/>
            <p:cNvSpPr/>
            <p:nvPr/>
          </p:nvSpPr>
          <p:spPr>
            <a:xfrm>
              <a:off x="4407857" y="1495971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679870" y="2314361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9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698324" y="2314361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50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752781" y="2314361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32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330845" y="1300796"/>
              <a:ext cx="12607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Control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277277" y="1300796"/>
              <a:ext cx="105990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rMDD</a:t>
              </a:r>
              <a:endParaRPr lang="en-GB" sz="2800" dirty="0"/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350988" y="108047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Supplementary Figure 6</a:t>
            </a:r>
          </a:p>
        </p:txBody>
      </p:sp>
    </p:spTree>
    <p:extLst>
      <p:ext uri="{BB962C8B-B14F-4D97-AF65-F5344CB8AC3E}">
        <p14:creationId xmlns:p14="http://schemas.microsoft.com/office/powerpoint/2010/main" val="9198660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314593" y="57578"/>
            <a:ext cx="7290795" cy="5158520"/>
            <a:chOff x="2602988" y="801610"/>
            <a:chExt cx="7290795" cy="5158520"/>
          </a:xfrm>
        </p:grpSpPr>
        <p:sp>
          <p:nvSpPr>
            <p:cNvPr id="4" name="Oval 3"/>
            <p:cNvSpPr/>
            <p:nvPr/>
          </p:nvSpPr>
          <p:spPr>
            <a:xfrm>
              <a:off x="3600000" y="2160000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Oval 4"/>
            <p:cNvSpPr/>
            <p:nvPr/>
          </p:nvSpPr>
          <p:spPr>
            <a:xfrm>
              <a:off x="4140000" y="3240000"/>
              <a:ext cx="2160000" cy="2160000"/>
            </a:xfrm>
            <a:prstGeom prst="ellipse">
              <a:avLst/>
            </a:prstGeom>
            <a:solidFill>
              <a:srgbClr val="92D05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" name="Oval 5"/>
            <p:cNvSpPr/>
            <p:nvPr/>
          </p:nvSpPr>
          <p:spPr>
            <a:xfrm>
              <a:off x="4680000" y="2160000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864925" y="2700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16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932977" y="2520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13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122898" y="2700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34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389856" y="3744000"/>
              <a:ext cx="6228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1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966184" y="3368269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8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611989" y="3744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19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105931" y="4595706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602988" y="1964825"/>
              <a:ext cx="12607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Control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549420" y="1964825"/>
              <a:ext cx="105990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rMDD</a:t>
              </a:r>
              <a:endParaRPr lang="en-GB" sz="28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705442" y="5436910"/>
              <a:ext cx="121539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xrMDD</a:t>
              </a:r>
              <a:endParaRPr lang="en-GB" sz="28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875008" y="801610"/>
              <a:ext cx="301877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Molecular Function</a:t>
              </a: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8137133" y="3891489"/>
            <a:ext cx="1508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DR Sig &lt; 0.05</a:t>
            </a:r>
          </a:p>
        </p:txBody>
      </p:sp>
      <p:grpSp>
        <p:nvGrpSpPr>
          <p:cNvPr id="20" name="Group 19"/>
          <p:cNvGrpSpPr/>
          <p:nvPr/>
        </p:nvGrpSpPr>
        <p:grpSpPr>
          <a:xfrm>
            <a:off x="6644050" y="1459250"/>
            <a:ext cx="5006338" cy="2355175"/>
            <a:chOff x="2330845" y="1300796"/>
            <a:chExt cx="5006338" cy="2355175"/>
          </a:xfrm>
        </p:grpSpPr>
        <p:sp>
          <p:nvSpPr>
            <p:cNvPr id="21" name="Oval 20"/>
            <p:cNvSpPr/>
            <p:nvPr/>
          </p:nvSpPr>
          <p:spPr>
            <a:xfrm>
              <a:off x="3327857" y="1495971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Oval 21"/>
            <p:cNvSpPr/>
            <p:nvPr/>
          </p:nvSpPr>
          <p:spPr>
            <a:xfrm>
              <a:off x="4407857" y="1495971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592782" y="2314361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17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698324" y="2314361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41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752781" y="2314361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53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330845" y="1300796"/>
              <a:ext cx="12607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Control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277277" y="1300796"/>
              <a:ext cx="105990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rMDD</a:t>
              </a:r>
              <a:endParaRPr lang="en-GB" sz="2800" dirty="0"/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350988" y="108047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Supplementary Figure 7</a:t>
            </a:r>
          </a:p>
        </p:txBody>
      </p:sp>
    </p:spTree>
    <p:extLst>
      <p:ext uri="{BB962C8B-B14F-4D97-AF65-F5344CB8AC3E}">
        <p14:creationId xmlns:p14="http://schemas.microsoft.com/office/powerpoint/2010/main" val="37592984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/>
          <p:cNvGrpSpPr/>
          <p:nvPr/>
        </p:nvGrpSpPr>
        <p:grpSpPr>
          <a:xfrm>
            <a:off x="537618" y="1226506"/>
            <a:ext cx="6314388" cy="3995305"/>
            <a:chOff x="2602988" y="1964825"/>
            <a:chExt cx="6314388" cy="3995305"/>
          </a:xfrm>
        </p:grpSpPr>
        <p:sp>
          <p:nvSpPr>
            <p:cNvPr id="34" name="Oval 33"/>
            <p:cNvSpPr/>
            <p:nvPr/>
          </p:nvSpPr>
          <p:spPr>
            <a:xfrm>
              <a:off x="3600000" y="2160000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" name="Oval 34"/>
            <p:cNvSpPr/>
            <p:nvPr/>
          </p:nvSpPr>
          <p:spPr>
            <a:xfrm>
              <a:off x="4140000" y="3240000"/>
              <a:ext cx="2160000" cy="2160000"/>
            </a:xfrm>
            <a:prstGeom prst="ellipse">
              <a:avLst/>
            </a:prstGeom>
            <a:solidFill>
              <a:srgbClr val="92D05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6" name="Oval 35"/>
            <p:cNvSpPr/>
            <p:nvPr/>
          </p:nvSpPr>
          <p:spPr>
            <a:xfrm>
              <a:off x="4680000" y="2160000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873357" y="2700000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412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931693" y="2520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30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976594" y="270000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3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336060" y="3744000"/>
              <a:ext cx="6228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38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023064" y="3368269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6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610845" y="3744000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5023064" y="4595706"/>
              <a:ext cx="36740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5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602988" y="1964825"/>
              <a:ext cx="102220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META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6549420" y="1964825"/>
              <a:ext cx="236795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Control_rMDD</a:t>
              </a:r>
              <a:endParaRPr lang="en-GB" sz="28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056512" y="5436910"/>
              <a:ext cx="224292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Control_MDD</a:t>
              </a:r>
              <a:endParaRPr lang="en-GB" sz="2800" dirty="0"/>
            </a:p>
          </p:txBody>
        </p:sp>
      </p:grpSp>
      <p:sp>
        <p:nvSpPr>
          <p:cNvPr id="48" name="TextBox 47"/>
          <p:cNvSpPr txBox="1"/>
          <p:nvPr/>
        </p:nvSpPr>
        <p:spPr>
          <a:xfrm>
            <a:off x="5859859" y="6257557"/>
            <a:ext cx="15263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DR Sig &lt; 0.05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39305" y="3617669"/>
            <a:ext cx="14234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Effects only in Control</a:t>
            </a:r>
          </a:p>
        </p:txBody>
      </p:sp>
      <p:grpSp>
        <p:nvGrpSpPr>
          <p:cNvPr id="53" name="Group 52"/>
          <p:cNvGrpSpPr/>
          <p:nvPr/>
        </p:nvGrpSpPr>
        <p:grpSpPr>
          <a:xfrm>
            <a:off x="6434500" y="1916450"/>
            <a:ext cx="5631279" cy="2355175"/>
            <a:chOff x="2635645" y="1300796"/>
            <a:chExt cx="5631279" cy="2355175"/>
          </a:xfrm>
        </p:grpSpPr>
        <p:sp>
          <p:nvSpPr>
            <p:cNvPr id="54" name="Oval 53"/>
            <p:cNvSpPr/>
            <p:nvPr/>
          </p:nvSpPr>
          <p:spPr>
            <a:xfrm>
              <a:off x="3327857" y="1495971"/>
              <a:ext cx="2160000" cy="2160000"/>
            </a:xfrm>
            <a:prstGeom prst="ellipse">
              <a:avLst/>
            </a:prstGeom>
            <a:solidFill>
              <a:srgbClr val="FF0000">
                <a:alpha val="50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" name="Oval 54"/>
            <p:cNvSpPr/>
            <p:nvPr/>
          </p:nvSpPr>
          <p:spPr>
            <a:xfrm>
              <a:off x="4407857" y="1495971"/>
              <a:ext cx="2160000" cy="2160000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592782" y="2314361"/>
              <a:ext cx="7328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412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600350" y="2314361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74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5665693" y="2314361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30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635645" y="1300796"/>
              <a:ext cx="102220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META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6277277" y="1300796"/>
              <a:ext cx="198964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MDD_rMDD</a:t>
              </a:r>
              <a:endParaRPr lang="en-GB" sz="2800" dirty="0"/>
            </a:p>
          </p:txBody>
        </p:sp>
      </p:grpSp>
      <p:sp>
        <p:nvSpPr>
          <p:cNvPr id="61" name="TextBox 60"/>
          <p:cNvSpPr txBox="1"/>
          <p:nvPr/>
        </p:nvSpPr>
        <p:spPr>
          <a:xfrm>
            <a:off x="3330579" y="6257557"/>
            <a:ext cx="2057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O gene sets 10532</a:t>
            </a:r>
          </a:p>
        </p:txBody>
      </p:sp>
      <p:graphicFrame>
        <p:nvGraphicFramePr>
          <p:cNvPr id="63" name="Table 62"/>
          <p:cNvGraphicFramePr>
            <a:graphicFrameLocks noGrp="1"/>
          </p:cNvGraphicFramePr>
          <p:nvPr/>
        </p:nvGraphicFramePr>
        <p:xfrm>
          <a:off x="5764592" y="4454500"/>
          <a:ext cx="5912940" cy="1676400"/>
        </p:xfrm>
        <a:graphic>
          <a:graphicData uri="http://schemas.openxmlformats.org/drawingml/2006/table">
            <a:tbl>
              <a:tblPr/>
              <a:tblGrid>
                <a:gridCol w="1970980">
                  <a:extLst>
                    <a:ext uri="{9D8B030D-6E8A-4147-A177-3AD203B41FA5}">
                      <a16:colId xmlns:a16="http://schemas.microsoft.com/office/drawing/2014/main" val="2111834754"/>
                    </a:ext>
                  </a:extLst>
                </a:gridCol>
                <a:gridCol w="1970980">
                  <a:extLst>
                    <a:ext uri="{9D8B030D-6E8A-4147-A177-3AD203B41FA5}">
                      <a16:colId xmlns:a16="http://schemas.microsoft.com/office/drawing/2014/main" val="322220012"/>
                    </a:ext>
                  </a:extLst>
                </a:gridCol>
                <a:gridCol w="1970980">
                  <a:extLst>
                    <a:ext uri="{9D8B030D-6E8A-4147-A177-3AD203B41FA5}">
                      <a16:colId xmlns:a16="http://schemas.microsoft.com/office/drawing/2014/main" val="379289371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t"/>
                      <a:r>
                        <a:rPr lang="en-GB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</a:rPr>
                        <a:t>List names</a:t>
                      </a:r>
                    </a:p>
                  </a:txBody>
                  <a:tcPr marL="38100" marR="38100" marT="38100" marB="38100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</a:rPr>
                        <a:t>number of elements</a:t>
                      </a:r>
                    </a:p>
                  </a:txBody>
                  <a:tcPr marL="38100" marR="38100" marT="38100" marB="38100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</a:rPr>
                        <a:t>number of unique elements</a:t>
                      </a:r>
                    </a:p>
                  </a:txBody>
                  <a:tcPr marL="38100" marR="38100" marT="38100" marB="38100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48442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t"/>
                      <a:r>
                        <a:rPr lang="en-GB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</a:rPr>
                        <a:t>mdd_rmdd</a:t>
                      </a:r>
                    </a:p>
                  </a:txBody>
                  <a:tcPr marL="38100" marR="38100" marT="38100" marB="38100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</a:rPr>
                        <a:t>112</a:t>
                      </a:r>
                    </a:p>
                  </a:txBody>
                  <a:tcPr marL="38100" marR="38100" marT="38100" marB="38100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</a:rPr>
                        <a:t>104</a:t>
                      </a:r>
                    </a:p>
                  </a:txBody>
                  <a:tcPr marL="38100" marR="38100" marT="38100" marB="38100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82491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t"/>
                      <a:r>
                        <a:rPr lang="en-GB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</a:rPr>
                        <a:t>meta</a:t>
                      </a:r>
                    </a:p>
                  </a:txBody>
                  <a:tcPr marL="38100" marR="38100" marT="38100" marB="38100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</a:rPr>
                        <a:t>486</a:t>
                      </a:r>
                    </a:p>
                  </a:txBody>
                  <a:tcPr marL="38100" marR="38100" marT="38100" marB="38100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</a:rPr>
                        <a:t>486</a:t>
                      </a:r>
                    </a:p>
                  </a:txBody>
                  <a:tcPr marL="38100" marR="38100" marT="38100" marB="38100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2731837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l" fontAlgn="t"/>
                      <a:r>
                        <a:rPr lang="en-GB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</a:rPr>
                        <a:t>Overall number of unique elements</a:t>
                      </a:r>
                    </a:p>
                  </a:txBody>
                  <a:tcPr marL="38100" marR="38100" marT="38100" marB="38100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dirty="0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</a:rPr>
                        <a:t>516</a:t>
                      </a:r>
                    </a:p>
                  </a:txBody>
                  <a:tcPr marL="38100" marR="38100" marT="38100" marB="38100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2835129"/>
                  </a:ext>
                </a:extLst>
              </a:tr>
            </a:tbl>
          </a:graphicData>
        </a:graphic>
      </p:graphicFrame>
      <p:sp>
        <p:nvSpPr>
          <p:cNvPr id="32" name="TextBox 31"/>
          <p:cNvSpPr txBox="1"/>
          <p:nvPr/>
        </p:nvSpPr>
        <p:spPr>
          <a:xfrm>
            <a:off x="350988" y="108047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Supplementary Figure 8</a:t>
            </a:r>
          </a:p>
        </p:txBody>
      </p:sp>
    </p:spTree>
    <p:extLst>
      <p:ext uri="{BB962C8B-B14F-4D97-AF65-F5344CB8AC3E}">
        <p14:creationId xmlns:p14="http://schemas.microsoft.com/office/powerpoint/2010/main" val="4706513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0988" y="108047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Supplementary Figure 8</a:t>
            </a:r>
          </a:p>
        </p:txBody>
      </p:sp>
      <p:grpSp>
        <p:nvGrpSpPr>
          <p:cNvPr id="38" name="Group 37"/>
          <p:cNvGrpSpPr/>
          <p:nvPr/>
        </p:nvGrpSpPr>
        <p:grpSpPr>
          <a:xfrm>
            <a:off x="920400" y="1171702"/>
            <a:ext cx="7346137" cy="5205001"/>
            <a:chOff x="920400" y="1171702"/>
            <a:chExt cx="7346137" cy="5205001"/>
          </a:xfrm>
        </p:grpSpPr>
        <p:grpSp>
          <p:nvGrpSpPr>
            <p:cNvPr id="17" name="Group 16"/>
            <p:cNvGrpSpPr/>
            <p:nvPr/>
          </p:nvGrpSpPr>
          <p:grpSpPr>
            <a:xfrm>
              <a:off x="2381117" y="1328128"/>
              <a:ext cx="5122841" cy="5048575"/>
              <a:chOff x="2381117" y="1328128"/>
              <a:chExt cx="5122841" cy="5048575"/>
            </a:xfrm>
          </p:grpSpPr>
          <p:sp>
            <p:nvSpPr>
              <p:cNvPr id="5" name="Flowchart: Alternate Process 4"/>
              <p:cNvSpPr/>
              <p:nvPr/>
            </p:nvSpPr>
            <p:spPr>
              <a:xfrm rot="2700000">
                <a:off x="1659958" y="3136703"/>
                <a:ext cx="4320000" cy="2160000"/>
              </a:xfrm>
              <a:prstGeom prst="flowChartAlternateProcess">
                <a:avLst/>
              </a:prstGeom>
              <a:solidFill>
                <a:srgbClr val="0070C0">
                  <a:alpha val="50000"/>
                </a:srgbClr>
              </a:solidFill>
              <a:ln w="381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" name="Flowchart: Alternate Process 5"/>
              <p:cNvSpPr/>
              <p:nvPr/>
            </p:nvSpPr>
            <p:spPr>
              <a:xfrm rot="2700000">
                <a:off x="2396559" y="2408128"/>
                <a:ext cx="4320000" cy="2160000"/>
              </a:xfrm>
              <a:prstGeom prst="flowChartAlternateProcess">
                <a:avLst/>
              </a:prstGeom>
              <a:solidFill>
                <a:srgbClr val="FF0000">
                  <a:alpha val="50000"/>
                </a:srgbClr>
              </a:solidFill>
              <a:ln w="381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" name="Flowchart: Alternate Process 7"/>
              <p:cNvSpPr/>
              <p:nvPr/>
            </p:nvSpPr>
            <p:spPr>
              <a:xfrm rot="18900000">
                <a:off x="2381117" y="2357329"/>
                <a:ext cx="4320000" cy="2160000"/>
              </a:xfrm>
              <a:prstGeom prst="flowChartAlternateProcess">
                <a:avLst/>
              </a:prstGeom>
              <a:solidFill>
                <a:srgbClr val="00B050">
                  <a:alpha val="50000"/>
                </a:srgbClr>
              </a:solidFill>
              <a:ln w="3810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" name="Flowchart: Alternate Process 8"/>
              <p:cNvSpPr/>
              <p:nvPr/>
            </p:nvSpPr>
            <p:spPr>
              <a:xfrm rot="-2700000">
                <a:off x="3183958" y="3149402"/>
                <a:ext cx="4320000" cy="2160000"/>
              </a:xfrm>
              <a:prstGeom prst="flowChartAlternateProcess">
                <a:avLst/>
              </a:prstGeom>
              <a:solidFill>
                <a:srgbClr val="FFC000">
                  <a:alpha val="50000"/>
                </a:srgbClr>
              </a:solidFill>
              <a:ln w="3810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2061618" y="1171702"/>
              <a:ext cx="126079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Control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920400" y="2494975"/>
              <a:ext cx="102220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META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852259" y="1171702"/>
              <a:ext cx="93487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MDD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206631" y="2494975"/>
              <a:ext cx="105990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 err="1"/>
                <a:t>rMDD</a:t>
              </a:r>
              <a:endParaRPr lang="en-GB" sz="28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972828" y="320205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43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777689" y="2423497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5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514291" y="1711147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6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514291" y="3202050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7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777689" y="3967792"/>
              <a:ext cx="55015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21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317613" y="2423497"/>
              <a:ext cx="46831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9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063920" y="1711147"/>
              <a:ext cx="57336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68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780991" y="2423497"/>
              <a:ext cx="57336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60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568187" y="3202050"/>
              <a:ext cx="61314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99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063920" y="3202050"/>
              <a:ext cx="57336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18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780991" y="3967792"/>
              <a:ext cx="57336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16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063920" y="4709066"/>
              <a:ext cx="57336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34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182072" y="3967792"/>
              <a:ext cx="73939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b="1" dirty="0"/>
                <a:t>257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249842" y="5530243"/>
              <a:ext cx="60385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16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516256" y="4709066"/>
              <a:ext cx="54622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63</a:t>
              </a:r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9433396" y="6274308"/>
            <a:ext cx="15263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DR Sig &lt; 0.05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6904116" y="6274308"/>
            <a:ext cx="2057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O gene sets 10532</a:t>
            </a:r>
          </a:p>
        </p:txBody>
      </p:sp>
    </p:spTree>
    <p:extLst>
      <p:ext uri="{BB962C8B-B14F-4D97-AF65-F5344CB8AC3E}">
        <p14:creationId xmlns:p14="http://schemas.microsoft.com/office/powerpoint/2010/main" val="1314881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4</TotalTime>
  <Words>357</Words>
  <Application>Microsoft Office PowerPoint</Application>
  <PresentationFormat>Widescreen</PresentationFormat>
  <Paragraphs>185</Paragraphs>
  <Slides>1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ppa Thomson</dc:creator>
  <cp:lastModifiedBy>Pippa Thomson</cp:lastModifiedBy>
  <cp:revision>36</cp:revision>
  <dcterms:created xsi:type="dcterms:W3CDTF">2023-08-11T15:28:20Z</dcterms:created>
  <dcterms:modified xsi:type="dcterms:W3CDTF">2023-12-04T10:22:01Z</dcterms:modified>
</cp:coreProperties>
</file>